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  <p:sldMasterId id="2147483684" r:id="rId2"/>
  </p:sldMasterIdLst>
  <p:sldIdLst>
    <p:sldId id="260" r:id="rId3"/>
  </p:sldIdLst>
  <p:sldSz cx="6858000" cy="9906000" type="A4"/>
  <p:notesSz cx="6858000" cy="9144000"/>
  <p:defaultTextStyle>
    <a:defPPr>
      <a:defRPr lang="en-US"/>
    </a:defPPr>
    <a:lvl1pPr marL="0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1pPr>
    <a:lvl2pPr marL="457117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2pPr>
    <a:lvl3pPr marL="914235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3pPr>
    <a:lvl4pPr marL="1371353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4pPr>
    <a:lvl5pPr marL="1828470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5pPr>
    <a:lvl6pPr marL="2285588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6pPr>
    <a:lvl7pPr marL="2742705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7pPr>
    <a:lvl8pPr marL="3199823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8pPr>
    <a:lvl9pPr marL="3656940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8000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1B60492-D762-4762-9EB3-C8B4B8E8E192}" v="1" dt="2022-08-10T16:47:44.53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7" d="100"/>
          <a:sy n="57" d="100"/>
        </p:scale>
        <p:origin x="2630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5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4" indent="0" algn="ctr">
              <a:buNone/>
              <a:defRPr sz="1500"/>
            </a:lvl2pPr>
            <a:lvl3pPr marL="685787" indent="0" algn="ctr">
              <a:buNone/>
              <a:defRPr sz="1350"/>
            </a:lvl3pPr>
            <a:lvl4pPr marL="1028681" indent="0" algn="ctr">
              <a:buNone/>
              <a:defRPr sz="1200"/>
            </a:lvl4pPr>
            <a:lvl5pPr marL="1371575" indent="0" algn="ctr">
              <a:buNone/>
              <a:defRPr sz="1200"/>
            </a:lvl5pPr>
            <a:lvl6pPr marL="1714468" indent="0" algn="ctr">
              <a:buNone/>
              <a:defRPr sz="1200"/>
            </a:lvl6pPr>
            <a:lvl7pPr marL="2057362" indent="0" algn="ctr">
              <a:buNone/>
              <a:defRPr sz="1200"/>
            </a:lvl7pPr>
            <a:lvl8pPr marL="2400256" indent="0" algn="ctr">
              <a:buNone/>
              <a:defRPr sz="1200"/>
            </a:lvl8pPr>
            <a:lvl9pPr marL="274315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9093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60830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4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4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32025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B09772-E514-45B9-8CF4-92DF4A61355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0838"/>
            <a:ext cx="5143500" cy="344963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10B107E-D851-4A12-AF94-3795778259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238"/>
            <a:ext cx="5143500" cy="23923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EED4F1-9F3A-456F-80DC-5DED50F7BF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43F402-3486-4322-8248-4BAC830984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552FD9-FD18-4157-9687-A8A4A14A4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07410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01DA3B-973B-4351-A78A-50D6F2F52E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4C3936-2E45-47F5-88F3-CC0FBE8D54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13BC8E-2B2C-4037-83EA-D6DE8A5C7A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4022F1-9174-4AA9-9B99-0522615906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4E1F1A-C3FB-42B5-96B2-AA7DDB520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36190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9AF10E-E890-48B5-B9DA-7DB62C863D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8313" y="2470150"/>
            <a:ext cx="5915025" cy="4119563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8AC4CF-EB1B-4163-AB69-524FAC55FA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8313" y="6629400"/>
            <a:ext cx="5915025" cy="2166938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06CEA9-E99A-48A1-9606-17174C455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866BD5-BB1E-4126-A0A8-E3E1A846B8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A13870-8824-49E0-9A21-3BF5A1F6B3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7967866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4B2F9F-6256-443A-9A23-B42146D665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2E53B4-9221-49A7-A6E7-FCCEF6836A5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6838"/>
            <a:ext cx="2881312" cy="62849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59B7275-D924-43C6-A4C7-66B557518B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505200" y="2636838"/>
            <a:ext cx="2881313" cy="62849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BD0C1F-73DC-43E9-B48D-D786852B70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95FBBF-74A2-4E6B-BC75-1E37657A2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C51576-CC48-498E-8765-DE56DAE5A7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26433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703F30-C803-47E4-8347-5E6023980D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3075" y="527050"/>
            <a:ext cx="5915025" cy="19145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BA377A-880F-4EC6-97FF-CAEBE1C583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3075" y="2428875"/>
            <a:ext cx="2900363" cy="11890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86F3534-8A8F-4D28-B44D-79D31C57D8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3075" y="3617913"/>
            <a:ext cx="2900363" cy="532288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AE94583-C1AF-41D9-9033-6050FDE773A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875"/>
            <a:ext cx="2916237" cy="11890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ADEE9E9-1F08-4E9A-A20D-A5DF3777F6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7913"/>
            <a:ext cx="2916237" cy="532288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FC1012B-0494-4A31-8816-3C59264163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B1BBDD3-2A6F-4A19-8A39-887DDC0851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68116A3-8B03-4714-8830-66560B9488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4749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4628F8-CF4E-488A-93AF-1BC5118B80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34E3929-5A95-436D-B902-CE72CF6B29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ABAB1B8-0FA4-41DE-BD94-D5A883C134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025A80C-9A52-4647-A2A9-6F6FB9C3AB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228155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6E630A6-7184-47A2-9972-68A98471D2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AC77312-F2DE-4132-9397-D14795928D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4B088FC-332A-4E9A-9CD0-BB20FAD2E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81809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48BCF8-8542-4164-8762-60C12241F7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3075" y="660400"/>
            <a:ext cx="2211388" cy="2311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38C008-472E-4C2E-A842-76D1B9F721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6238" y="1425575"/>
            <a:ext cx="3471862" cy="704056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E83FB18-C304-4CC4-9A13-ED8C38F16B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3075" y="2971800"/>
            <a:ext cx="2211388" cy="550545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1B6FC1-91E3-4769-A0B1-C0DCC4B705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6C68DB-9C40-4AE0-96F4-82A16DC4EB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5ABE2B-7320-4B70-8DF1-4A75C7DFA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344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40801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4E560F-FBA5-4A57-BAAB-B5B245AF65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3075" y="660400"/>
            <a:ext cx="2211388" cy="2311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D06DF3D-976B-41C0-8413-E44AB344322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6238" y="1425575"/>
            <a:ext cx="3471862" cy="704056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99E36D-E537-456F-A46E-D956F8FA29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3075" y="2971800"/>
            <a:ext cx="2211388" cy="550545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1EBEAB-7AD1-4AC6-8783-9A3BFDD6FF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D40531-89C0-454E-A9D7-6412C7CC68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B01019-E7CE-47CA-92FF-7434AF3B2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57353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623F2D-2D6D-4BF4-96F3-A38D85AA68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5284063-D278-4428-A223-48C303113D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9DE4D9-9DFD-4B19-9A4B-F4A9711AF2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BF7B78-D83E-482B-8423-D48D005E94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5AAD84-DF58-4E58-B84B-940D4E8584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08542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0FD37CB-620B-4C5A-886D-763C2B493C6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8550" y="527050"/>
            <a:ext cx="1477963" cy="83947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FBB42B9-5DBB-4588-803A-5E31F1002E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8" y="527050"/>
            <a:ext cx="4284662" cy="83947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98DE5B-9C7F-4C6C-88C6-A7DE08E4AC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AABC10-CB61-4AD4-A91B-39588FE542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55FAA9-D874-44EA-9C94-8FF9115EC5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3239018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F9165A-EB3D-4DE9-956A-6302BF2737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9ED5DFB-FAC6-419C-B452-9ED84B38F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A69401A-86BB-478E-8EE9-747E0FDF4D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50C80AC-60F4-4902-9B12-604D070910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1292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7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94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87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8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7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6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6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5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5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635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77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4" indent="0">
              <a:buNone/>
              <a:defRPr sz="1500" b="1"/>
            </a:lvl2pPr>
            <a:lvl3pPr marL="685787" indent="0">
              <a:buNone/>
              <a:defRPr sz="1350" b="1"/>
            </a:lvl3pPr>
            <a:lvl4pPr marL="1028681" indent="0">
              <a:buNone/>
              <a:defRPr sz="1200" b="1"/>
            </a:lvl4pPr>
            <a:lvl5pPr marL="1371575" indent="0">
              <a:buNone/>
              <a:defRPr sz="1200" b="1"/>
            </a:lvl5pPr>
            <a:lvl6pPr marL="1714468" indent="0">
              <a:buNone/>
              <a:defRPr sz="1200" b="1"/>
            </a:lvl6pPr>
            <a:lvl7pPr marL="2057362" indent="0">
              <a:buNone/>
              <a:defRPr sz="1200" b="1"/>
            </a:lvl7pPr>
            <a:lvl8pPr marL="2400256" indent="0">
              <a:buNone/>
              <a:defRPr sz="1200" b="1"/>
            </a:lvl8pPr>
            <a:lvl9pPr marL="274315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4" indent="0">
              <a:buNone/>
              <a:defRPr sz="1500" b="1"/>
            </a:lvl2pPr>
            <a:lvl3pPr marL="685787" indent="0">
              <a:buNone/>
              <a:defRPr sz="1350" b="1"/>
            </a:lvl3pPr>
            <a:lvl4pPr marL="1028681" indent="0">
              <a:buNone/>
              <a:defRPr sz="1200" b="1"/>
            </a:lvl4pPr>
            <a:lvl5pPr marL="1371575" indent="0">
              <a:buNone/>
              <a:defRPr sz="1200" b="1"/>
            </a:lvl5pPr>
            <a:lvl6pPr marL="1714468" indent="0">
              <a:buNone/>
              <a:defRPr sz="1200" b="1"/>
            </a:lvl6pPr>
            <a:lvl7pPr marL="2057362" indent="0">
              <a:buNone/>
              <a:defRPr sz="1200" b="1"/>
            </a:lvl7pPr>
            <a:lvl8pPr marL="2400256" indent="0">
              <a:buNone/>
              <a:defRPr sz="1200" b="1"/>
            </a:lvl8pPr>
            <a:lvl9pPr marL="274315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8133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886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0916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1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94" indent="0">
              <a:buNone/>
              <a:defRPr sz="1050"/>
            </a:lvl2pPr>
            <a:lvl3pPr marL="685787" indent="0">
              <a:buNone/>
              <a:defRPr sz="900"/>
            </a:lvl3pPr>
            <a:lvl4pPr marL="1028681" indent="0">
              <a:buNone/>
              <a:defRPr sz="750"/>
            </a:lvl4pPr>
            <a:lvl5pPr marL="1371575" indent="0">
              <a:buNone/>
              <a:defRPr sz="750"/>
            </a:lvl5pPr>
            <a:lvl6pPr marL="1714468" indent="0">
              <a:buNone/>
              <a:defRPr sz="750"/>
            </a:lvl6pPr>
            <a:lvl7pPr marL="2057362" indent="0">
              <a:buNone/>
              <a:defRPr sz="750"/>
            </a:lvl7pPr>
            <a:lvl8pPr marL="2400256" indent="0">
              <a:buNone/>
              <a:defRPr sz="750"/>
            </a:lvl8pPr>
            <a:lvl9pPr marL="274315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4931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94" indent="0">
              <a:buNone/>
              <a:defRPr sz="2100"/>
            </a:lvl2pPr>
            <a:lvl3pPr marL="685787" indent="0">
              <a:buNone/>
              <a:defRPr sz="1800"/>
            </a:lvl3pPr>
            <a:lvl4pPr marL="1028681" indent="0">
              <a:buNone/>
              <a:defRPr sz="1500"/>
            </a:lvl4pPr>
            <a:lvl5pPr marL="1371575" indent="0">
              <a:buNone/>
              <a:defRPr sz="1500"/>
            </a:lvl5pPr>
            <a:lvl6pPr marL="1714468" indent="0">
              <a:buNone/>
              <a:defRPr sz="1500"/>
            </a:lvl6pPr>
            <a:lvl7pPr marL="2057362" indent="0">
              <a:buNone/>
              <a:defRPr sz="1500"/>
            </a:lvl7pPr>
            <a:lvl8pPr marL="2400256" indent="0">
              <a:buNone/>
              <a:defRPr sz="1500"/>
            </a:lvl8pPr>
            <a:lvl9pPr marL="274315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1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94" indent="0">
              <a:buNone/>
              <a:defRPr sz="1050"/>
            </a:lvl2pPr>
            <a:lvl3pPr marL="685787" indent="0">
              <a:buNone/>
              <a:defRPr sz="900"/>
            </a:lvl3pPr>
            <a:lvl4pPr marL="1028681" indent="0">
              <a:buNone/>
              <a:defRPr sz="750"/>
            </a:lvl4pPr>
            <a:lvl5pPr marL="1371575" indent="0">
              <a:buNone/>
              <a:defRPr sz="750"/>
            </a:lvl5pPr>
            <a:lvl6pPr marL="1714468" indent="0">
              <a:buNone/>
              <a:defRPr sz="750"/>
            </a:lvl6pPr>
            <a:lvl7pPr marL="2057362" indent="0">
              <a:buNone/>
              <a:defRPr sz="750"/>
            </a:lvl7pPr>
            <a:lvl8pPr marL="2400256" indent="0">
              <a:buNone/>
              <a:defRPr sz="750"/>
            </a:lvl8pPr>
            <a:lvl9pPr marL="274315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2563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8FB57F-F3C2-44F1-BDA1-59B168DF83F1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450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87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7" indent="-171447" algn="l" defTabSz="685787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41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34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8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22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15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09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03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97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4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7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81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75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68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62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56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50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1FEA7FF-5392-453F-B97E-628C7A0696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050"/>
            <a:ext cx="5915025" cy="19145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00A679-CADD-47AC-953E-FE520426FE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6838"/>
            <a:ext cx="5915025" cy="62849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79E62A-4952-4FF1-8805-218D387117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923A10-7854-46EF-8C3E-A0D0F7144EA0}" type="datetimeFigureOut">
              <a:rPr lang="en-US" smtClean="0"/>
              <a:t>8/1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294C13-E29D-41AC-93DC-B46213509B0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2100"/>
            <a:ext cx="2314575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FB7D7B-27F5-48A9-AB98-28A54E3D8A4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7097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  <p:sldLayoutId id="2147483696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Map&#10;&#10;Description automatically generated with medium confidence">
            <a:extLst>
              <a:ext uri="{FF2B5EF4-FFF2-40B4-BE49-F238E27FC236}">
                <a16:creationId xmlns:a16="http://schemas.microsoft.com/office/drawing/2014/main" id="{BDAD1667-10ED-331F-8AEA-53637D6E47C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3726" y="708873"/>
            <a:ext cx="3428999" cy="2581835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1687F51D-B7FC-4C4C-8ACC-5CEA8C41A32C}"/>
              </a:ext>
            </a:extLst>
          </p:cNvPr>
          <p:cNvSpPr txBox="1"/>
          <p:nvPr/>
        </p:nvSpPr>
        <p:spPr>
          <a:xfrm>
            <a:off x="0" y="-29165"/>
            <a:ext cx="47823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sp>
        <p:nvSpPr>
          <p:cNvPr id="270" name="TextBox 269">
            <a:extLst>
              <a:ext uri="{FF2B5EF4-FFF2-40B4-BE49-F238E27FC236}">
                <a16:creationId xmlns:a16="http://schemas.microsoft.com/office/drawing/2014/main" id="{A0AC0307-3144-A0AD-4BF9-37EABB13A354}"/>
              </a:ext>
            </a:extLst>
          </p:cNvPr>
          <p:cNvSpPr txBox="1"/>
          <p:nvPr/>
        </p:nvSpPr>
        <p:spPr>
          <a:xfrm>
            <a:off x="117290" y="8953610"/>
            <a:ext cx="662342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DEC treatment does not affect enterocyte integrity. Transverse H&amp; E section of the </a:t>
            </a:r>
            <a:r>
              <a:rPr lang="en-US" sz="11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caris 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testine and underlyin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 muscle bags. 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: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fore DEC treatment, 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: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 minutes after exposure to 10µM exposure to DEC . 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: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fter 60 minutes washing APF Ringer at the end of the recordings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ajor structures are highlighted</a:t>
            </a:r>
            <a:r>
              <a:rPr lang="en-US" sz="110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endParaRPr lang="en-US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C49D44C3-6E89-8B21-4DF2-9C4661751E91}"/>
              </a:ext>
            </a:extLst>
          </p:cNvPr>
          <p:cNvSpPr txBox="1"/>
          <p:nvPr/>
        </p:nvSpPr>
        <p:spPr>
          <a:xfrm>
            <a:off x="1290916" y="465068"/>
            <a:ext cx="424543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84FB4C20-B43B-D713-8506-77643449572A}"/>
              </a:ext>
            </a:extLst>
          </p:cNvPr>
          <p:cNvSpPr txBox="1"/>
          <p:nvPr/>
        </p:nvSpPr>
        <p:spPr>
          <a:xfrm>
            <a:off x="1290917" y="3305988"/>
            <a:ext cx="424543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4CBC076-AD3F-84E3-22D0-8B92CA20FFD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9587" y="6379556"/>
            <a:ext cx="3428999" cy="2581835"/>
          </a:xfrm>
          <a:prstGeom prst="rect">
            <a:avLst/>
          </a:prstGeom>
        </p:spPr>
      </p:pic>
      <p:sp>
        <p:nvSpPr>
          <p:cNvPr id="70" name="TextBox 69">
            <a:extLst>
              <a:ext uri="{FF2B5EF4-FFF2-40B4-BE49-F238E27FC236}">
                <a16:creationId xmlns:a16="http://schemas.microsoft.com/office/drawing/2014/main" id="{0C1BC35C-E5D1-9A1C-D0A1-40757DFE6B0C}"/>
              </a:ext>
            </a:extLst>
          </p:cNvPr>
          <p:cNvSpPr txBox="1"/>
          <p:nvPr/>
        </p:nvSpPr>
        <p:spPr>
          <a:xfrm>
            <a:off x="1300955" y="6097766"/>
            <a:ext cx="424543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6468DAD5-C84E-F5D6-9825-71A36600847F}"/>
              </a:ext>
            </a:extLst>
          </p:cNvPr>
          <p:cNvCxnSpPr/>
          <p:nvPr/>
        </p:nvCxnSpPr>
        <p:spPr>
          <a:xfrm flipH="1">
            <a:off x="4009294" y="7098321"/>
            <a:ext cx="445476" cy="33997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9AFF84E0-0D58-F9B6-E1F2-ABFCF275B869}"/>
              </a:ext>
            </a:extLst>
          </p:cNvPr>
          <p:cNvSpPr txBox="1"/>
          <p:nvPr/>
        </p:nvSpPr>
        <p:spPr>
          <a:xfrm>
            <a:off x="3833447" y="6890973"/>
            <a:ext cx="12426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rush border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B908BD1E-E086-692E-184F-88050B0B9CAB}"/>
              </a:ext>
            </a:extLst>
          </p:cNvPr>
          <p:cNvCxnSpPr/>
          <p:nvPr/>
        </p:nvCxnSpPr>
        <p:spPr>
          <a:xfrm flipH="1">
            <a:off x="2425856" y="7096611"/>
            <a:ext cx="445476" cy="33997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74A540DC-3088-0EAC-EA23-12C5E2B958EF}"/>
              </a:ext>
            </a:extLst>
          </p:cNvPr>
          <p:cNvSpPr txBox="1"/>
          <p:nvPr/>
        </p:nvSpPr>
        <p:spPr>
          <a:xfrm>
            <a:off x="2250009" y="6890973"/>
            <a:ext cx="12426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nterocyte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0F1EE4AD-5259-04DD-A18B-20B6E4D3ED67}"/>
              </a:ext>
            </a:extLst>
          </p:cNvPr>
          <p:cNvCxnSpPr>
            <a:cxnSpLocks/>
          </p:cNvCxnSpPr>
          <p:nvPr/>
        </p:nvCxnSpPr>
        <p:spPr>
          <a:xfrm flipH="1" flipV="1">
            <a:off x="3686560" y="1779235"/>
            <a:ext cx="573552" cy="30139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10FBB6AD-3B08-C5B2-458C-0885C3AAF1E5}"/>
              </a:ext>
            </a:extLst>
          </p:cNvPr>
          <p:cNvSpPr txBox="1"/>
          <p:nvPr/>
        </p:nvSpPr>
        <p:spPr>
          <a:xfrm>
            <a:off x="4008946" y="1578201"/>
            <a:ext cx="12426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asolateral 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embrane</a:t>
            </a:r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8DF4C2D8-7208-1186-0C67-E960B5327684}"/>
              </a:ext>
            </a:extLst>
          </p:cNvPr>
          <p:cNvCxnSpPr>
            <a:cxnSpLocks/>
          </p:cNvCxnSpPr>
          <p:nvPr/>
        </p:nvCxnSpPr>
        <p:spPr>
          <a:xfrm>
            <a:off x="4307883" y="950694"/>
            <a:ext cx="0" cy="271057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DA782E5B-F995-C560-9371-CB3C19E6B7B3}"/>
              </a:ext>
            </a:extLst>
          </p:cNvPr>
          <p:cNvSpPr txBox="1"/>
          <p:nvPr/>
        </p:nvSpPr>
        <p:spPr>
          <a:xfrm>
            <a:off x="3686560" y="703005"/>
            <a:ext cx="12426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rush border</a:t>
            </a:r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5D1F0EE6-0CBA-8784-1375-1C95D2442F7A}"/>
              </a:ext>
            </a:extLst>
          </p:cNvPr>
          <p:cNvCxnSpPr>
            <a:cxnSpLocks/>
          </p:cNvCxnSpPr>
          <p:nvPr/>
        </p:nvCxnSpPr>
        <p:spPr>
          <a:xfrm flipH="1">
            <a:off x="2161140" y="1212034"/>
            <a:ext cx="100467" cy="625693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418F7380-4637-861A-A17E-32006842FAF3}"/>
              </a:ext>
            </a:extLst>
          </p:cNvPr>
          <p:cNvSpPr txBox="1"/>
          <p:nvPr/>
        </p:nvSpPr>
        <p:spPr>
          <a:xfrm>
            <a:off x="1699848" y="935035"/>
            <a:ext cx="12426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nterocyte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3308EA1D-9FB9-EF3D-F33E-C8DB0E7A6D38}"/>
              </a:ext>
            </a:extLst>
          </p:cNvPr>
          <p:cNvCxnSpPr>
            <a:cxnSpLocks/>
          </p:cNvCxnSpPr>
          <p:nvPr/>
        </p:nvCxnSpPr>
        <p:spPr>
          <a:xfrm flipH="1">
            <a:off x="4781914" y="2673432"/>
            <a:ext cx="492717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E44474FE-D85B-03F4-065A-B3D65E2D8BD5}"/>
              </a:ext>
            </a:extLst>
          </p:cNvPr>
          <p:cNvSpPr txBox="1"/>
          <p:nvPr/>
        </p:nvSpPr>
        <p:spPr>
          <a:xfrm>
            <a:off x="5087120" y="2529541"/>
            <a:ext cx="12426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uscle bag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3C0943BC-7DFA-8FD7-D943-B03E2E2E47C6}"/>
              </a:ext>
            </a:extLst>
          </p:cNvPr>
          <p:cNvGrpSpPr/>
          <p:nvPr/>
        </p:nvGrpSpPr>
        <p:grpSpPr>
          <a:xfrm>
            <a:off x="1503187" y="3555524"/>
            <a:ext cx="3803363" cy="2581835"/>
            <a:chOff x="1513226" y="3607959"/>
            <a:chExt cx="3803363" cy="2581835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390E29B2-B1CF-3D2C-3D30-057AB5E5D1E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633726" y="3607959"/>
              <a:ext cx="3428999" cy="2581835"/>
            </a:xfrm>
            <a:prstGeom prst="rect">
              <a:avLst/>
            </a:prstGeom>
          </p:spPr>
        </p:pic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DB77BCF5-4002-BD79-1B7D-DE49E93BF8A4}"/>
                </a:ext>
              </a:extLst>
            </p:cNvPr>
            <p:cNvCxnSpPr>
              <a:cxnSpLocks/>
              <a:stCxn id="21" idx="2"/>
            </p:cNvCxnSpPr>
            <p:nvPr/>
          </p:nvCxnSpPr>
          <p:spPr>
            <a:xfrm>
              <a:off x="3604847" y="4454800"/>
              <a:ext cx="0" cy="271057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4A112AAD-39D1-5319-DE1F-65017FAFE47A}"/>
                </a:ext>
              </a:extLst>
            </p:cNvPr>
            <p:cNvSpPr txBox="1"/>
            <p:nvPr/>
          </p:nvSpPr>
          <p:spPr>
            <a:xfrm>
              <a:off x="2983524" y="4177801"/>
              <a:ext cx="12426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rush border</a:t>
              </a:r>
            </a:p>
          </p:txBody>
        </p: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16D5382E-DAAC-3095-B2F0-7329FBC4E2C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974518" y="5041422"/>
              <a:ext cx="100467" cy="625693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9FC22B2-0EF4-8FFE-6272-319DE7402459}"/>
                </a:ext>
              </a:extLst>
            </p:cNvPr>
            <p:cNvSpPr txBox="1"/>
            <p:nvPr/>
          </p:nvSpPr>
          <p:spPr>
            <a:xfrm>
              <a:off x="1513226" y="4764423"/>
              <a:ext cx="12426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Enterocyte</a:t>
              </a:r>
            </a:p>
          </p:txBody>
        </p:sp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0F943602-D253-374C-0F55-C410A2E7BD0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581226" y="5799089"/>
              <a:ext cx="492717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87A93971-CF9D-F90C-DAF3-FC249821BF63}"/>
                </a:ext>
              </a:extLst>
            </p:cNvPr>
            <p:cNvSpPr txBox="1"/>
            <p:nvPr/>
          </p:nvSpPr>
          <p:spPr>
            <a:xfrm>
              <a:off x="3886432" y="5655198"/>
              <a:ext cx="12426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uscle bag</a:t>
              </a:r>
            </a:p>
          </p:txBody>
        </p:sp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id="{B9037520-3C25-51CF-2B1E-155F5177D6E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763108" y="5091804"/>
              <a:ext cx="562001" cy="16001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50D0A303-B517-C2C9-83D9-46A6B9923C21}"/>
                </a:ext>
              </a:extLst>
            </p:cNvPr>
            <p:cNvSpPr txBox="1"/>
            <p:nvPr/>
          </p:nvSpPr>
          <p:spPr>
            <a:xfrm>
              <a:off x="4073943" y="4860631"/>
              <a:ext cx="124264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asolateral </a:t>
              </a:r>
            </a:p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embrane</a:t>
              </a:r>
            </a:p>
          </p:txBody>
        </p:sp>
      </p:grp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B6BCCEC0-1A72-4573-A268-77BE24F4389C}"/>
              </a:ext>
            </a:extLst>
          </p:cNvPr>
          <p:cNvCxnSpPr>
            <a:cxnSpLocks/>
          </p:cNvCxnSpPr>
          <p:nvPr/>
        </p:nvCxnSpPr>
        <p:spPr>
          <a:xfrm>
            <a:off x="1639587" y="8208783"/>
            <a:ext cx="527415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624BA190-C277-DB04-279B-7AA3B0379E62}"/>
              </a:ext>
            </a:extLst>
          </p:cNvPr>
          <p:cNvSpPr txBox="1"/>
          <p:nvPr/>
        </p:nvSpPr>
        <p:spPr>
          <a:xfrm>
            <a:off x="602986" y="8053168"/>
            <a:ext cx="12426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uscle bag</a:t>
            </a:r>
          </a:p>
        </p:txBody>
      </p: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0BF7A6CC-BED9-3537-644B-DAFE094F0F3B}"/>
              </a:ext>
            </a:extLst>
          </p:cNvPr>
          <p:cNvCxnSpPr>
            <a:cxnSpLocks/>
          </p:cNvCxnSpPr>
          <p:nvPr/>
        </p:nvCxnSpPr>
        <p:spPr>
          <a:xfrm flipH="1" flipV="1">
            <a:off x="4787776" y="8161920"/>
            <a:ext cx="562001" cy="34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8CB49CE3-7CAB-0187-3605-E7DD6DE76AF1}"/>
              </a:ext>
            </a:extLst>
          </p:cNvPr>
          <p:cNvSpPr txBox="1"/>
          <p:nvPr/>
        </p:nvSpPr>
        <p:spPr>
          <a:xfrm>
            <a:off x="5146317" y="7931087"/>
            <a:ext cx="12426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asolateral 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embrane</a:t>
            </a:r>
          </a:p>
        </p:txBody>
      </p:sp>
    </p:spTree>
    <p:extLst>
      <p:ext uri="{BB962C8B-B14F-4D97-AF65-F5344CB8AC3E}">
        <p14:creationId xmlns:p14="http://schemas.microsoft.com/office/powerpoint/2010/main" val="40395406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899</TotalTime>
  <Words>91</Words>
  <Application>Microsoft Office PowerPoint</Application>
  <PresentationFormat>A4 Paper (210x297 mm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Custom Desig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Williams</dc:creator>
  <cp:lastModifiedBy>Paul Williams</cp:lastModifiedBy>
  <cp:revision>136</cp:revision>
  <dcterms:created xsi:type="dcterms:W3CDTF">2020-10-13T16:20:28Z</dcterms:created>
  <dcterms:modified xsi:type="dcterms:W3CDTF">2022-08-11T20:11:18Z</dcterms:modified>
</cp:coreProperties>
</file>